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6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</p:sldIdLst>
  <p:sldSz cx="6858000" cy="9144000"/>
  <p:notesSz cx="7099300" cy="10234613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B62F0FC-5B0F-4E78-9A0C-B37F020DB0C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3681D8-0ABB-453C-88CC-3316FDCFE83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8CF590-540F-405E-BF9A-547B8CB52BD8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7F26556-E947-4CF1-95F1-44E4F548EB74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74A29FC-FF9C-4F1C-BBFF-ED1FE5A96C0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813219-D780-498F-B4B7-2F5407434E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80BA1C0-1C8E-4AB0-917C-C1FB9A73426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F2B118-BBCF-401A-8FB8-0E01BBCCC95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9150D9C-FBF8-4809-81A3-30D968B4EA7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6F69708-F600-4BE6-A104-9113E6FEC79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E92B7D-79D4-45B8-B33E-66A0FF186BF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A7A4D6D-416C-434D-AB00-20AF0701847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3.png"/><Relationship Id="rId2" Type="http://schemas.openxmlformats.org/officeDocument/2006/relationships/image" Target="../media/image4.png"/><Relationship Id="rId3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5.png"/><Relationship Id="rId2" Type="http://schemas.openxmlformats.org/officeDocument/2006/relationships/image" Target="../media/image6.pn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549360" y="1790640"/>
            <a:ext cx="5472000" cy="34592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549360" y="5394240"/>
            <a:ext cx="5472000" cy="364176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43" name=""/>
          <p:cNvSpPr/>
          <p:nvPr/>
        </p:nvSpPr>
        <p:spPr>
          <a:xfrm>
            <a:off x="622080" y="179064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0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620640" y="5394240"/>
            <a:ext cx="36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0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0" y="0"/>
            <a:ext cx="352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Kleemann et al., 2007, Additional data file 6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404640" y="327960"/>
            <a:ext cx="5904000" cy="1736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ctr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dditional data file 6: Biological networks of differentially expressed genes for HC allowing the identification of transcriptional master regulators.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 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Red (blue) dots in right corner of a gene indicate upregulation (downregulation) of a particular gene. Networks shown in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, B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nd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 C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are representative networks used to identify transcriptional (master) regulators that control the gene expression changes under HC conditions (threshold of significance for networks P&lt;0.01). Metabolites are indicated       . </a:t>
            </a: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D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, Legend for networks (from MetaCore guideline)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1143000" y="1490760"/>
            <a:ext cx="216000" cy="144360"/>
          </a:xfrm>
          <a:prstGeom prst="hexagon">
            <a:avLst>
              <a:gd name="adj" fmla="val 37406"/>
              <a:gd name="vf" fmla="val 115470"/>
            </a:avLst>
          </a:prstGeom>
          <a:solidFill>
            <a:srgbClr val="aa21e7"/>
          </a:solidFill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4280" bIns="44280" anchor="ctr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05BA27A-EF2A-44D0-B6AB-467CC6931EB1}" type="slidenum">
              <a:t>1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"/>
          <p:cNvSpPr/>
          <p:nvPr/>
        </p:nvSpPr>
        <p:spPr>
          <a:xfrm>
            <a:off x="0" y="0"/>
            <a:ext cx="352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Kleemann et al., 200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1"/>
          <a:srcRect l="14180" t="23342" r="9037" b="11938"/>
          <a:stretch/>
        </p:blipFill>
        <p:spPr>
          <a:xfrm>
            <a:off x="549360" y="611280"/>
            <a:ext cx="6119640" cy="4384440"/>
          </a:xfrm>
          <a:prstGeom prst="rect">
            <a:avLst/>
          </a:prstGeom>
          <a:ln w="9360">
            <a:solidFill>
              <a:srgbClr val="000000"/>
            </a:solidFill>
            <a:miter/>
          </a:ln>
        </p:spPr>
      </p:pic>
      <p:sp>
        <p:nvSpPr>
          <p:cNvPr id="50" name=""/>
          <p:cNvSpPr/>
          <p:nvPr/>
        </p:nvSpPr>
        <p:spPr>
          <a:xfrm>
            <a:off x="550800" y="611280"/>
            <a:ext cx="3650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000" spc="-1" strike="noStrike">
                <a:solidFill>
                  <a:srgbClr val="000000"/>
                </a:solidFill>
                <a:latin typeface="Arial"/>
              </a:rPr>
              <a:t>C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115920" y="5219640"/>
            <a:ext cx="36828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000" spc="-1" strike="noStrike">
                <a:solidFill>
                  <a:srgbClr val="000000"/>
                </a:solidFill>
                <a:latin typeface="Arial"/>
              </a:rPr>
              <a:t>D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2" name="" descr=""/>
          <p:cNvPicPr/>
          <p:nvPr/>
        </p:nvPicPr>
        <p:blipFill>
          <a:blip r:embed="rId2"/>
          <a:srcRect l="1771" t="9033" r="29226" b="13670"/>
          <a:stretch/>
        </p:blipFill>
        <p:spPr>
          <a:xfrm>
            <a:off x="765000" y="5364000"/>
            <a:ext cx="4753080" cy="352584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AE0C0F-3B6F-4E3E-924D-8201B6F986CB}" type="slidenum">
              <a:t>2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"/>
          <p:cNvSpPr/>
          <p:nvPr/>
        </p:nvSpPr>
        <p:spPr>
          <a:xfrm>
            <a:off x="0" y="0"/>
            <a:ext cx="352728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nl-NL" sz="1200" spc="-1" strike="noStrike">
                <a:solidFill>
                  <a:srgbClr val="000000"/>
                </a:solidFill>
                <a:latin typeface="Arial"/>
              </a:rPr>
              <a:t>Kleemann et al., 2007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404640" y="324000"/>
            <a:ext cx="165600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nl-NL" sz="2000" spc="-1" strike="noStrike">
                <a:solidFill>
                  <a:srgbClr val="000000"/>
                </a:solidFill>
                <a:latin typeface="Arial"/>
              </a:rPr>
              <a:t>D </a:t>
            </a:r>
            <a:r>
              <a:rPr b="1" lang="nl-NL" sz="800" spc="-1" strike="noStrike">
                <a:solidFill>
                  <a:srgbClr val="000000"/>
                </a:solidFill>
                <a:latin typeface="Arial"/>
              </a:rPr>
              <a:t>(continued)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55" name="" descr=""/>
          <p:cNvPicPr/>
          <p:nvPr/>
        </p:nvPicPr>
        <p:blipFill>
          <a:blip r:embed="rId1"/>
          <a:srcRect l="1464" t="14427" r="29317" b="8070"/>
          <a:stretch/>
        </p:blipFill>
        <p:spPr>
          <a:xfrm>
            <a:off x="1125360" y="714240"/>
            <a:ext cx="3743640" cy="3353040"/>
          </a:xfrm>
          <a:prstGeom prst="rect">
            <a:avLst/>
          </a:prstGeom>
          <a:ln w="0">
            <a:noFill/>
          </a:ln>
        </p:spPr>
      </p:pic>
      <p:pic>
        <p:nvPicPr>
          <p:cNvPr id="56" name="" descr=""/>
          <p:cNvPicPr/>
          <p:nvPr/>
        </p:nvPicPr>
        <p:blipFill>
          <a:blip r:embed="rId2"/>
          <a:srcRect l="61404" t="13651" r="3100" b="11322"/>
          <a:stretch/>
        </p:blipFill>
        <p:spPr>
          <a:xfrm>
            <a:off x="1125360" y="4067280"/>
            <a:ext cx="2486160" cy="3384360"/>
          </a:xfrm>
          <a:prstGeom prst="rect">
            <a:avLst/>
          </a:prstGeom>
          <a:ln w="0">
            <a:noFill/>
          </a:ln>
        </p:spPr>
      </p:pic>
      <p:sp>
        <p:nvSpPr>
          <p:cNvPr id="2" name="PlaceHolder 1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9C1CD5-461F-43AF-950B-B71234F09635}" type="slidenum">
              <a:t>3</a:t>
            </a:fld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721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5-03-16T09:17:31Z</dcterms:created>
  <dc:creator>verschl</dc:creator>
  <dc:description/>
  <dc:language>en-US</dc:language>
  <cp:lastModifiedBy>kleemannr</cp:lastModifiedBy>
  <dcterms:modified xsi:type="dcterms:W3CDTF">2007-07-13T09:50:10Z</dcterms:modified>
  <cp:revision>127</cp:revision>
  <dc:subject/>
  <dc:title>Dia 1</dc:title>
</cp:coreProperties>
</file>